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19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ol.missouri.edu\files\Nguyen%20Folders\lab%20members\Song,%20Li\publication%20outline-Li%20Song-2013-2014\RNA-seq%20root%20paper\qPCR%20design%20and%20results%20and%20analysis\correlations%20of%20expression%20level%20analyzed%20by%20log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617279982859289E-2"/>
          <c:y val="2.1104789036825292E-2"/>
          <c:w val="0.88946435267020196"/>
          <c:h val="0.91546587259853796"/>
        </c:manualLayout>
      </c:layout>
      <c:scatterChart>
        <c:scatterStyle val="lineMarker"/>
        <c:varyColors val="0"/>
        <c:ser>
          <c:idx val="0"/>
          <c:order val="0"/>
          <c:tx>
            <c:strRef>
              <c:f>'[correlations of expression level analyzed by log2.xlsx]figure data-2'!$C$1</c:f>
              <c:strCache>
                <c:ptCount val="1"/>
                <c:pt idx="0">
                  <c:v>qPCR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  <a:round/>
              </a:ln>
              <a:effectLst/>
            </c:spPr>
          </c:marker>
          <c:trendline>
            <c:spPr>
              <a:ln w="9525" cap="rnd">
                <a:solidFill>
                  <a:schemeClr val="accent1"/>
                </a:solidFill>
              </a:ln>
              <a:effectLst/>
            </c:spPr>
            <c:trendlineType val="linear"/>
            <c:forward val="2"/>
            <c:dispRSqr val="0"/>
            <c:dispEq val="0"/>
          </c:trendline>
          <c:trendline>
            <c:spPr>
              <a:ln w="9525" cap="rnd">
                <a:solidFill>
                  <a:schemeClr val="accent1"/>
                </a:solidFill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0.4051681430446194"/>
                  <c:y val="-8.6370521640998121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1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[correlations of expression level analyzed by log2.xlsx]figure data-2'!$D$1:$D$72</c:f>
              <c:numCache>
                <c:formatCode>General</c:formatCode>
                <c:ptCount val="72"/>
                <c:pt idx="0">
                  <c:v>-0.136181</c:v>
                </c:pt>
                <c:pt idx="1">
                  <c:v>0.349775</c:v>
                </c:pt>
                <c:pt idx="2">
                  <c:v>3.2368299999999999</c:v>
                </c:pt>
                <c:pt idx="3">
                  <c:v>1.0140100000000001</c:v>
                </c:pt>
                <c:pt idx="4">
                  <c:v>1.90398</c:v>
                </c:pt>
                <c:pt idx="5">
                  <c:v>2.30837</c:v>
                </c:pt>
                <c:pt idx="6">
                  <c:v>0.13883799999999999</c:v>
                </c:pt>
                <c:pt idx="7">
                  <c:v>0.15490100000000001</c:v>
                </c:pt>
                <c:pt idx="8">
                  <c:v>1.77474</c:v>
                </c:pt>
                <c:pt idx="9">
                  <c:v>0.39931299999999997</c:v>
                </c:pt>
                <c:pt idx="10">
                  <c:v>-1.1746300000000001</c:v>
                </c:pt>
                <c:pt idx="11">
                  <c:v>-0.32674599999999998</c:v>
                </c:pt>
                <c:pt idx="12">
                  <c:v>-1.6679900000000001</c:v>
                </c:pt>
                <c:pt idx="13">
                  <c:v>-2.6678799999999999E-2</c:v>
                </c:pt>
                <c:pt idx="14">
                  <c:v>-8.5643700000000003E-2</c:v>
                </c:pt>
                <c:pt idx="15">
                  <c:v>0.71645199999999998</c:v>
                </c:pt>
                <c:pt idx="16">
                  <c:v>0.690716</c:v>
                </c:pt>
                <c:pt idx="17">
                  <c:v>0.33005299999999999</c:v>
                </c:pt>
                <c:pt idx="18">
                  <c:v>-2.0918299999999999</c:v>
                </c:pt>
                <c:pt idx="19">
                  <c:v>5.6803499999999998</c:v>
                </c:pt>
                <c:pt idx="20">
                  <c:v>2.0922900000000002</c:v>
                </c:pt>
                <c:pt idx="21">
                  <c:v>6.2400900000000004</c:v>
                </c:pt>
                <c:pt idx="22">
                  <c:v>2.5103800000000001</c:v>
                </c:pt>
                <c:pt idx="23">
                  <c:v>6.4054799999999998</c:v>
                </c:pt>
                <c:pt idx="24">
                  <c:v>2.2718500000000001</c:v>
                </c:pt>
                <c:pt idx="25">
                  <c:v>3.1888200000000002</c:v>
                </c:pt>
                <c:pt idx="26">
                  <c:v>4.9398999999999997</c:v>
                </c:pt>
                <c:pt idx="27">
                  <c:v>-2.5850599999999999</c:v>
                </c:pt>
                <c:pt idx="28">
                  <c:v>4.7015799999999999</c:v>
                </c:pt>
                <c:pt idx="29">
                  <c:v>-2.11382</c:v>
                </c:pt>
                <c:pt idx="30">
                  <c:v>-3.2326000000000001</c:v>
                </c:pt>
                <c:pt idx="31">
                  <c:v>-3.2322600000000001</c:v>
                </c:pt>
                <c:pt idx="32">
                  <c:v>-1.6030199999999999</c:v>
                </c:pt>
                <c:pt idx="33">
                  <c:v>2.5142000000000002</c:v>
                </c:pt>
                <c:pt idx="34">
                  <c:v>2.4571499999999999</c:v>
                </c:pt>
                <c:pt idx="35">
                  <c:v>2.7224400000000002</c:v>
                </c:pt>
                <c:pt idx="36">
                  <c:v>-3.48536</c:v>
                </c:pt>
                <c:pt idx="37">
                  <c:v>5.1696999999999997</c:v>
                </c:pt>
                <c:pt idx="38">
                  <c:v>2.0893899999999999</c:v>
                </c:pt>
                <c:pt idx="39">
                  <c:v>4.18621</c:v>
                </c:pt>
                <c:pt idx="40">
                  <c:v>2.9976500000000001</c:v>
                </c:pt>
                <c:pt idx="41">
                  <c:v>7.06006</c:v>
                </c:pt>
                <c:pt idx="42">
                  <c:v>2.0479799999999999</c:v>
                </c:pt>
                <c:pt idx="43">
                  <c:v>4.4642400000000002</c:v>
                </c:pt>
                <c:pt idx="44">
                  <c:v>6.3295399999999997</c:v>
                </c:pt>
                <c:pt idx="45">
                  <c:v>-5.92326</c:v>
                </c:pt>
                <c:pt idx="46">
                  <c:v>3.5214500000000002</c:v>
                </c:pt>
                <c:pt idx="47">
                  <c:v>-4.1995300000000002</c:v>
                </c:pt>
                <c:pt idx="48">
                  <c:v>-2.7344200000000001</c:v>
                </c:pt>
                <c:pt idx="49">
                  <c:v>-4.82742</c:v>
                </c:pt>
                <c:pt idx="50">
                  <c:v>-3.0844399999999998</c:v>
                </c:pt>
                <c:pt idx="51">
                  <c:v>2.74119</c:v>
                </c:pt>
                <c:pt idx="52">
                  <c:v>2.75482</c:v>
                </c:pt>
                <c:pt idx="53">
                  <c:v>1.9105300000000001</c:v>
                </c:pt>
                <c:pt idx="54">
                  <c:v>0.72396400000000005</c:v>
                </c:pt>
                <c:pt idx="55">
                  <c:v>1.5772999999999999</c:v>
                </c:pt>
                <c:pt idx="56">
                  <c:v>1.0825400000000001</c:v>
                </c:pt>
                <c:pt idx="57">
                  <c:v>2.1836899999999999</c:v>
                </c:pt>
                <c:pt idx="58">
                  <c:v>-1.38656</c:v>
                </c:pt>
                <c:pt idx="59">
                  <c:v>2.4175200000000001</c:v>
                </c:pt>
                <c:pt idx="60">
                  <c:v>-9.3854200000000002E-3</c:v>
                </c:pt>
                <c:pt idx="61">
                  <c:v>0.15812899999999999</c:v>
                </c:pt>
                <c:pt idx="62">
                  <c:v>-1.88639</c:v>
                </c:pt>
                <c:pt idx="63">
                  <c:v>-5.7126599999999996</c:v>
                </c:pt>
                <c:pt idx="64">
                  <c:v>1.2204900000000001</c:v>
                </c:pt>
                <c:pt idx="65">
                  <c:v>-1.49986</c:v>
                </c:pt>
                <c:pt idx="66">
                  <c:v>2</c:v>
                </c:pt>
                <c:pt idx="67">
                  <c:v>-3.7342499999999998</c:v>
                </c:pt>
                <c:pt idx="68">
                  <c:v>-1.17296</c:v>
                </c:pt>
                <c:pt idx="69">
                  <c:v>1.49211</c:v>
                </c:pt>
                <c:pt idx="70">
                  <c:v>1.4371100000000001</c:v>
                </c:pt>
                <c:pt idx="71">
                  <c:v>-0.92478199999999999</c:v>
                </c:pt>
              </c:numCache>
            </c:numRef>
          </c:xVal>
          <c:yVal>
            <c:numRef>
              <c:f>'[correlations of expression level analyzed by log2.xlsx]figure data-2'!$E$1:$E$72</c:f>
              <c:numCache>
                <c:formatCode>General</c:formatCode>
                <c:ptCount val="72"/>
                <c:pt idx="0">
                  <c:v>-0.95131169053915487</c:v>
                </c:pt>
                <c:pt idx="1">
                  <c:v>-0.72857036912936579</c:v>
                </c:pt>
                <c:pt idx="2">
                  <c:v>2.9494478776558193</c:v>
                </c:pt>
                <c:pt idx="3">
                  <c:v>-1.5011799394980679E-2</c:v>
                </c:pt>
                <c:pt idx="4">
                  <c:v>0.89734108676269664</c:v>
                </c:pt>
                <c:pt idx="5">
                  <c:v>4.1571440537734664E-2</c:v>
                </c:pt>
                <c:pt idx="6">
                  <c:v>0.32905472765017874</c:v>
                </c:pt>
                <c:pt idx="7">
                  <c:v>-1.9730009461647362</c:v>
                </c:pt>
                <c:pt idx="8">
                  <c:v>1.6619792687346078</c:v>
                </c:pt>
                <c:pt idx="9">
                  <c:v>0.42105265622336585</c:v>
                </c:pt>
                <c:pt idx="10">
                  <c:v>-0.86660230738854083</c:v>
                </c:pt>
                <c:pt idx="11">
                  <c:v>-0.58043548956044178</c:v>
                </c:pt>
                <c:pt idx="12">
                  <c:v>-1.173287068340874</c:v>
                </c:pt>
                <c:pt idx="13">
                  <c:v>-0.20329781501392125</c:v>
                </c:pt>
                <c:pt idx="14">
                  <c:v>-0.15771595842207242</c:v>
                </c:pt>
                <c:pt idx="15">
                  <c:v>0.49077901472944041</c:v>
                </c:pt>
                <c:pt idx="16">
                  <c:v>0.38466078276863036</c:v>
                </c:pt>
                <c:pt idx="17">
                  <c:v>-0.10190333790919824</c:v>
                </c:pt>
                <c:pt idx="18">
                  <c:v>-0.56892392392647362</c:v>
                </c:pt>
                <c:pt idx="19">
                  <c:v>7.1837052854785588</c:v>
                </c:pt>
                <c:pt idx="20">
                  <c:v>3.4619191261648607</c:v>
                </c:pt>
                <c:pt idx="21">
                  <c:v>6.3103282000130019</c:v>
                </c:pt>
                <c:pt idx="22">
                  <c:v>3.9558498042476788</c:v>
                </c:pt>
                <c:pt idx="23">
                  <c:v>7.7287393642742721</c:v>
                </c:pt>
                <c:pt idx="24">
                  <c:v>1.9427679491137302</c:v>
                </c:pt>
                <c:pt idx="25">
                  <c:v>3.4639975483172778</c:v>
                </c:pt>
                <c:pt idx="26">
                  <c:v>5.2645332046498403</c:v>
                </c:pt>
                <c:pt idx="27">
                  <c:v>-2.4543688590558315</c:v>
                </c:pt>
                <c:pt idx="28">
                  <c:v>1.0663488804465426</c:v>
                </c:pt>
                <c:pt idx="29">
                  <c:v>-1.4340297015654537</c:v>
                </c:pt>
                <c:pt idx="30">
                  <c:v>-1.6388819027882742</c:v>
                </c:pt>
                <c:pt idx="31">
                  <c:v>-2.3451470424391379</c:v>
                </c:pt>
                <c:pt idx="32">
                  <c:v>-0.99627562843797701</c:v>
                </c:pt>
                <c:pt idx="33">
                  <c:v>2.7065380409958584</c:v>
                </c:pt>
                <c:pt idx="34">
                  <c:v>2.8621323901691604</c:v>
                </c:pt>
                <c:pt idx="35">
                  <c:v>3.298329791509556</c:v>
                </c:pt>
                <c:pt idx="36">
                  <c:v>-3.3857720791410024</c:v>
                </c:pt>
                <c:pt idx="37">
                  <c:v>5.0114737772446407</c:v>
                </c:pt>
                <c:pt idx="38">
                  <c:v>2.0586925777654619</c:v>
                </c:pt>
                <c:pt idx="39">
                  <c:v>4.2844459337315399</c:v>
                </c:pt>
                <c:pt idx="40">
                  <c:v>3.0122587009147725</c:v>
                </c:pt>
                <c:pt idx="41">
                  <c:v>6.5737554172255788</c:v>
                </c:pt>
                <c:pt idx="42">
                  <c:v>3.3802893857419312</c:v>
                </c:pt>
                <c:pt idx="43">
                  <c:v>3.9841731887402685</c:v>
                </c:pt>
                <c:pt idx="44">
                  <c:v>6.9251914195148681</c:v>
                </c:pt>
                <c:pt idx="45">
                  <c:v>-2.7677288769056889</c:v>
                </c:pt>
                <c:pt idx="46">
                  <c:v>1.5655032659574293</c:v>
                </c:pt>
                <c:pt idx="47">
                  <c:v>-3.1176570160649923</c:v>
                </c:pt>
                <c:pt idx="48">
                  <c:v>-0.78771487202429202</c:v>
                </c:pt>
                <c:pt idx="49">
                  <c:v>-2.5744012036825801</c:v>
                </c:pt>
                <c:pt idx="50">
                  <c:v>-1.9485668474033493</c:v>
                </c:pt>
                <c:pt idx="51">
                  <c:v>2.6235646413225644</c:v>
                </c:pt>
                <c:pt idx="52">
                  <c:v>3.0450758278501797</c:v>
                </c:pt>
                <c:pt idx="53">
                  <c:v>2.4311848455776661</c:v>
                </c:pt>
                <c:pt idx="54">
                  <c:v>0.58197622431893037</c:v>
                </c:pt>
                <c:pt idx="55">
                  <c:v>1.259265049854607</c:v>
                </c:pt>
                <c:pt idx="56">
                  <c:v>0.87258662363872364</c:v>
                </c:pt>
                <c:pt idx="57">
                  <c:v>2.128139745083359</c:v>
                </c:pt>
                <c:pt idx="58">
                  <c:v>-0.54550932917435213</c:v>
                </c:pt>
                <c:pt idx="59">
                  <c:v>2.8993207717021257</c:v>
                </c:pt>
                <c:pt idx="60">
                  <c:v>1.1687428413016576</c:v>
                </c:pt>
                <c:pt idx="61">
                  <c:v>1.5785592994370363</c:v>
                </c:pt>
                <c:pt idx="62">
                  <c:v>-0.94960031210728302</c:v>
                </c:pt>
                <c:pt idx="63">
                  <c:v>-5.2092565583292867</c:v>
                </c:pt>
                <c:pt idx="64">
                  <c:v>0.25555882491694037</c:v>
                </c:pt>
                <c:pt idx="65">
                  <c:v>-1.6264515571314073</c:v>
                </c:pt>
                <c:pt idx="66">
                  <c:v>-2.1932916595259493</c:v>
                </c:pt>
                <c:pt idx="67">
                  <c:v>-1.6199020682548564</c:v>
                </c:pt>
                <c:pt idx="68">
                  <c:v>-1.1912926953868879</c:v>
                </c:pt>
                <c:pt idx="69">
                  <c:v>0.23134501019281178</c:v>
                </c:pt>
                <c:pt idx="70">
                  <c:v>0.72009499395662613</c:v>
                </c:pt>
                <c:pt idx="71">
                  <c:v>-1.6129931965618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6183232"/>
        <c:axId val="436183624"/>
      </c:scatterChart>
      <c:valAx>
        <c:axId val="4361832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cap="all" spc="120" normalizeH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36183624"/>
        <c:crosses val="autoZero"/>
        <c:crossBetween val="midCat"/>
        <c:majorUnit val="2"/>
      </c:valAx>
      <c:valAx>
        <c:axId val="4361836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36183232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334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892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694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530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871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712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070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200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217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601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5A994-45DF-4A76-8AFA-B8FEEA7C1132}" type="datetimeFigureOut">
              <a:rPr lang="en-US" smtClean="0"/>
              <a:t>11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22E9DF-E529-440C-A9B2-C23256380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725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1529862" y="984739"/>
          <a:ext cx="3376246" cy="26288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162908" y="3587262"/>
            <a:ext cx="2395207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by RNA-</a:t>
            </a:r>
            <a:r>
              <a:rPr lang="en-US" sz="1108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og2)</a:t>
            </a:r>
            <a:endParaRPr lang="en-US" sz="110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281345" y="2117291"/>
            <a:ext cx="2190023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by </a:t>
            </a:r>
            <a:r>
              <a:rPr lang="en-US" sz="1108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en-US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og2)</a:t>
            </a:r>
            <a:endParaRPr lang="en-US" sz="110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207332" y="281355"/>
            <a:ext cx="260885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2" i="1" dirty="0"/>
              <a:t>Song et al., </a:t>
            </a:r>
            <a:r>
              <a:rPr lang="en-US" sz="1662" i="1" dirty="0" smtClean="0"/>
              <a:t>Additional file13</a:t>
            </a:r>
            <a:endParaRPr lang="en-US" sz="1662" i="1" dirty="0"/>
          </a:p>
        </p:txBody>
      </p:sp>
    </p:spTree>
    <p:extLst>
      <p:ext uri="{BB962C8B-B14F-4D97-AF65-F5344CB8AC3E}">
        <p14:creationId xmlns:p14="http://schemas.microsoft.com/office/powerpoint/2010/main" val="348814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20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Missour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g, Li</dc:creator>
  <cp:lastModifiedBy>Song, Li</cp:lastModifiedBy>
  <cp:revision>2</cp:revision>
  <dcterms:created xsi:type="dcterms:W3CDTF">2015-11-03T21:02:36Z</dcterms:created>
  <dcterms:modified xsi:type="dcterms:W3CDTF">2015-11-03T21:25:12Z</dcterms:modified>
</cp:coreProperties>
</file>